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480175" cy="828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08" userDrawn="1">
          <p15:clr>
            <a:srgbClr val="A4A3A4"/>
          </p15:clr>
        </p15:guide>
        <p15:guide id="2" pos="204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3953" autoAdjust="0"/>
  </p:normalViewPr>
  <p:slideViewPr>
    <p:cSldViewPr snapToGrid="0" showGuides="1">
      <p:cViewPr varScale="1">
        <p:scale>
          <a:sx n="94" d="100"/>
          <a:sy n="94" d="100"/>
        </p:scale>
        <p:origin x="2880" y="90"/>
      </p:cViewPr>
      <p:guideLst>
        <p:guide orient="horz" pos="2608"/>
        <p:guide pos="204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355149"/>
            <a:ext cx="5508149" cy="2882806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4349128"/>
            <a:ext cx="4860131" cy="1999179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F1ED-F081-4C55-A020-71DA9A1BFE67}" type="datetimeFigureOut">
              <a:rPr lang="en-US" smtClean="0"/>
              <a:t>1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85CCF-D447-4823-A112-1973BE7A622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96791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F1ED-F081-4C55-A020-71DA9A1BFE67}" type="datetimeFigureOut">
              <a:rPr lang="en-US" smtClean="0"/>
              <a:t>1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85CCF-D447-4823-A112-1973BE7A622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051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440855"/>
            <a:ext cx="1397288" cy="7017256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440855"/>
            <a:ext cx="4110861" cy="7017256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F1ED-F081-4C55-A020-71DA9A1BFE67}" type="datetimeFigureOut">
              <a:rPr lang="en-US" smtClean="0"/>
              <a:t>1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85CCF-D447-4823-A112-1973BE7A622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9257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F1ED-F081-4C55-A020-71DA9A1BFE67}" type="datetimeFigureOut">
              <a:rPr lang="en-US" smtClean="0"/>
              <a:t>1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85CCF-D447-4823-A112-1973BE7A622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83624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2064352"/>
            <a:ext cx="5589151" cy="3444416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5541353"/>
            <a:ext cx="5589151" cy="1811337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F1ED-F081-4C55-A020-71DA9A1BFE67}" type="datetimeFigureOut">
              <a:rPr lang="en-US" smtClean="0"/>
              <a:t>1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85CCF-D447-4823-A112-1973BE7A622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7400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204273"/>
            <a:ext cx="2754074" cy="52538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204273"/>
            <a:ext cx="2754074" cy="52538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F1ED-F081-4C55-A020-71DA9A1BFE67}" type="datetimeFigureOut">
              <a:rPr lang="en-US" smtClean="0"/>
              <a:t>11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85CCF-D447-4823-A112-1973BE7A622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840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40856"/>
            <a:ext cx="5589151" cy="160049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2029849"/>
            <a:ext cx="2741417" cy="994797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3024646"/>
            <a:ext cx="2741417" cy="4448799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2029849"/>
            <a:ext cx="2754918" cy="994797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3024646"/>
            <a:ext cx="2754918" cy="4448799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F1ED-F081-4C55-A020-71DA9A1BFE67}" type="datetimeFigureOut">
              <a:rPr lang="en-US" smtClean="0"/>
              <a:t>11/2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85CCF-D447-4823-A112-1973BE7A622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6222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F1ED-F081-4C55-A020-71DA9A1BFE67}" type="datetimeFigureOut">
              <a:rPr lang="en-US" smtClean="0"/>
              <a:t>11/2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85CCF-D447-4823-A112-1973BE7A622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945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F1ED-F081-4C55-A020-71DA9A1BFE67}" type="datetimeFigureOut">
              <a:rPr lang="en-US" smtClean="0"/>
              <a:t>11/2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85CCF-D447-4823-A112-1973BE7A622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2499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52027"/>
            <a:ext cx="2090025" cy="1932093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192226"/>
            <a:ext cx="3280589" cy="5884451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484120"/>
            <a:ext cx="2090025" cy="4602140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F1ED-F081-4C55-A020-71DA9A1BFE67}" type="datetimeFigureOut">
              <a:rPr lang="en-US" smtClean="0"/>
              <a:t>11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85CCF-D447-4823-A112-1973BE7A622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12865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52027"/>
            <a:ext cx="2090025" cy="1932093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192226"/>
            <a:ext cx="3280589" cy="5884451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484120"/>
            <a:ext cx="2090025" cy="4602140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F1ED-F081-4C55-A020-71DA9A1BFE67}" type="datetimeFigureOut">
              <a:rPr lang="en-US" smtClean="0"/>
              <a:t>11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85CCF-D447-4823-A112-1973BE7A622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8077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440856"/>
            <a:ext cx="5589151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204273"/>
            <a:ext cx="5589151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7674706"/>
            <a:ext cx="1458039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9EF1ED-F081-4C55-A020-71DA9A1BFE67}" type="datetimeFigureOut">
              <a:rPr lang="en-US" smtClean="0"/>
              <a:t>1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7674706"/>
            <a:ext cx="2187059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7674706"/>
            <a:ext cx="1458039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785CCF-D447-4823-A112-1973BE7A622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6367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9699"/>
          <a:stretch/>
        </p:blipFill>
        <p:spPr>
          <a:xfrm>
            <a:off x="452470" y="3115507"/>
            <a:ext cx="1886370" cy="2889053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804" y="622838"/>
            <a:ext cx="1892036" cy="2324269"/>
          </a:xfrm>
          <a:prstGeom prst="rect">
            <a:avLst/>
          </a:prstGeom>
        </p:spPr>
      </p:pic>
      <p:sp>
        <p:nvSpPr>
          <p:cNvPr id="7" name="Textfeld 6"/>
          <p:cNvSpPr txBox="1"/>
          <p:nvPr/>
        </p:nvSpPr>
        <p:spPr>
          <a:xfrm>
            <a:off x="2318341" y="2101816"/>
            <a:ext cx="290466" cy="1754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VP-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2318341" y="5121193"/>
            <a:ext cx="396831" cy="1754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2312674" y="649467"/>
            <a:ext cx="1465451" cy="3948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irst incubation with VP-1</a:t>
            </a:r>
          </a:p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econdary antibody goat a mouse 800</a:t>
            </a:r>
          </a:p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cquisition at 800 nm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2318341" y="3137412"/>
            <a:ext cx="1705020" cy="3948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econd incubation with GAPDH on same blot</a:t>
            </a:r>
          </a:p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econdary antibody goat a rabbit 680</a:t>
            </a:r>
          </a:p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cquisition at 680 nm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858976" y="471301"/>
            <a:ext cx="133404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993187" y="471301"/>
            <a:ext cx="147321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1136871" y="471301"/>
            <a:ext cx="133404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1280649" y="471301"/>
            <a:ext cx="147321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1414860" y="471301"/>
            <a:ext cx="133404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1558543" y="471301"/>
            <a:ext cx="147321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1717730" y="471301"/>
            <a:ext cx="234799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PM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834262" y="336929"/>
            <a:ext cx="39792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0.01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1717730" y="359789"/>
            <a:ext cx="220882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MOI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1409092" y="336929"/>
            <a:ext cx="286554" cy="1425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1124830" y="336929"/>
            <a:ext cx="39792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Gerader Verbinder 22"/>
          <p:cNvCxnSpPr/>
          <p:nvPr/>
        </p:nvCxnSpPr>
        <p:spPr>
          <a:xfrm>
            <a:off x="868450" y="486597"/>
            <a:ext cx="23759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r Verbinder 23"/>
          <p:cNvCxnSpPr/>
          <p:nvPr/>
        </p:nvCxnSpPr>
        <p:spPr>
          <a:xfrm>
            <a:off x="1156201" y="486597"/>
            <a:ext cx="23759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r Verbinder 24"/>
          <p:cNvCxnSpPr/>
          <p:nvPr/>
        </p:nvCxnSpPr>
        <p:spPr>
          <a:xfrm>
            <a:off x="1448814" y="486597"/>
            <a:ext cx="23759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feld 25"/>
          <p:cNvSpPr txBox="1"/>
          <p:nvPr/>
        </p:nvSpPr>
        <p:spPr>
          <a:xfrm>
            <a:off x="-36187" y="1959243"/>
            <a:ext cx="290466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-36187" y="1490663"/>
            <a:ext cx="290466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-36187" y="1056150"/>
            <a:ext cx="290466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-67003" y="865844"/>
            <a:ext cx="321282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-67003" y="675539"/>
            <a:ext cx="321282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-36187" y="5094235"/>
            <a:ext cx="290466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-36187" y="4506183"/>
            <a:ext cx="290466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-36187" y="3968490"/>
            <a:ext cx="290466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-67003" y="3707588"/>
            <a:ext cx="321282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-67003" y="3517282"/>
            <a:ext cx="321282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64275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4</Words>
  <Application>Microsoft Office PowerPoint</Application>
  <PresentationFormat>Benutzerdefiniert</PresentationFormat>
  <Paragraphs>2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Charité Universitaetsmedizin Berl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Goetzke, Carl Christoph</dc:creator>
  <cp:lastModifiedBy>Beling, Antje</cp:lastModifiedBy>
  <cp:revision>8</cp:revision>
  <dcterms:created xsi:type="dcterms:W3CDTF">2017-11-27T13:22:35Z</dcterms:created>
  <dcterms:modified xsi:type="dcterms:W3CDTF">2017-11-28T08:53:10Z</dcterms:modified>
</cp:coreProperties>
</file>